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C0839-94C7-4BD9-980A-6938EEBEFB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E147E-01E6-4045-9A4E-B8EF322484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42E3B-57C4-4373-BB91-00A6A04C80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1467D-0A19-4508-9C49-B0752FB06A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16E552-D183-4982-84F4-51585AE0A9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05736-119E-45ED-8006-5D100986FF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B79257-7B79-4004-9122-1C8F7D0F2F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0A4F8-0886-44AF-B8E9-A93260C261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CB915-0FDC-4CC1-A144-8C0F066737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CADFF-BAF8-4B1E-A9D1-21BB0271DB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3BF42-6B3F-4F45-BB28-B0B9F4888E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BF38A-BE61-4C15-BF9E-70AE2F149C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4EF258-6B5C-405F-B30D-EF789896661B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2008080" y="847800"/>
            <a:ext cx="4997520" cy="2170080"/>
          </a:xfrm>
          <a:prstGeom prst="rect">
            <a:avLst/>
          </a:prstGeom>
          <a:ln w="0">
            <a:noFill/>
          </a:ln>
        </p:spPr>
      </p:pic>
      <p:sp>
        <p:nvSpPr>
          <p:cNvPr id="42" name="TextBox 18"/>
          <p:cNvSpPr/>
          <p:nvPr/>
        </p:nvSpPr>
        <p:spPr>
          <a:xfrm>
            <a:off x="2322000" y="852480"/>
            <a:ext cx="5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500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26"/>
          <p:cNvSpPr/>
          <p:nvPr/>
        </p:nvSpPr>
        <p:spPr>
          <a:xfrm>
            <a:off x="2971440" y="853920"/>
            <a:ext cx="5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250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7"/>
          <p:cNvSpPr/>
          <p:nvPr/>
        </p:nvSpPr>
        <p:spPr>
          <a:xfrm>
            <a:off x="3601440" y="853920"/>
            <a:ext cx="5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125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8"/>
          <p:cNvSpPr/>
          <p:nvPr/>
        </p:nvSpPr>
        <p:spPr>
          <a:xfrm>
            <a:off x="4284000" y="853920"/>
            <a:ext cx="4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62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9"/>
          <p:cNvSpPr/>
          <p:nvPr/>
        </p:nvSpPr>
        <p:spPr>
          <a:xfrm>
            <a:off x="4906440" y="861840"/>
            <a:ext cx="4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31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30"/>
          <p:cNvSpPr/>
          <p:nvPr/>
        </p:nvSpPr>
        <p:spPr>
          <a:xfrm>
            <a:off x="5465160" y="871560"/>
            <a:ext cx="4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15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1"/>
          <p:cNvSpPr/>
          <p:nvPr/>
        </p:nvSpPr>
        <p:spPr>
          <a:xfrm>
            <a:off x="6041880" y="871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7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2"/>
          <p:cNvSpPr/>
          <p:nvPr/>
        </p:nvSpPr>
        <p:spPr>
          <a:xfrm>
            <a:off x="592920" y="1082520"/>
            <a:ext cx="147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Protein G (pg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3"/>
          <p:cNvSpPr/>
          <p:nvPr/>
        </p:nvSpPr>
        <p:spPr>
          <a:xfrm>
            <a:off x="2257200" y="2077920"/>
            <a:ext cx="57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1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4"/>
          <p:cNvSpPr/>
          <p:nvPr/>
        </p:nvSpPr>
        <p:spPr>
          <a:xfrm>
            <a:off x="2852280" y="2079720"/>
            <a:ext cx="57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5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5"/>
          <p:cNvSpPr/>
          <p:nvPr/>
        </p:nvSpPr>
        <p:spPr>
          <a:xfrm>
            <a:off x="3448080" y="208908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2.5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6"/>
          <p:cNvSpPr/>
          <p:nvPr/>
        </p:nvSpPr>
        <p:spPr>
          <a:xfrm>
            <a:off x="4034160" y="2089080"/>
            <a:ext cx="80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1.25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7"/>
          <p:cNvSpPr/>
          <p:nvPr/>
        </p:nvSpPr>
        <p:spPr>
          <a:xfrm>
            <a:off x="4727160" y="2089080"/>
            <a:ext cx="80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6.25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8"/>
          <p:cNvSpPr/>
          <p:nvPr/>
        </p:nvSpPr>
        <p:spPr>
          <a:xfrm>
            <a:off x="5401800" y="2089080"/>
            <a:ext cx="89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3.125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9"/>
          <p:cNvSpPr/>
          <p:nvPr/>
        </p:nvSpPr>
        <p:spPr>
          <a:xfrm>
            <a:off x="6156720" y="2089080"/>
            <a:ext cx="80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1.56x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Calibri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40"/>
          <p:cNvSpPr/>
          <p:nvPr/>
        </p:nvSpPr>
        <p:spPr>
          <a:xfrm>
            <a:off x="577800" y="2247840"/>
            <a:ext cx="1596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Number of virus particl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1"/>
          <p:cNvSpPr/>
          <p:nvPr/>
        </p:nvSpPr>
        <p:spPr>
          <a:xfrm>
            <a:off x="418680" y="6134040"/>
            <a:ext cx="241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gure 1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3"/>
          <p:cNvSpPr/>
          <p:nvPr/>
        </p:nvSpPr>
        <p:spPr>
          <a:xfrm>
            <a:off x="754200" y="1020600"/>
            <a:ext cx="819936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Supplementary Figure 1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Dot blot analysis illustrating Protein G standards (top row) ranging from 5000 pg (left) to 78 pg (right).  Bottom row shows StrepGpcAdluc serially diluted from 1 x 10</a:t>
            </a:r>
            <a:r>
              <a:rPr b="0" lang="en-GB" sz="1800" spc="-1" strike="noStrike" baseline="30000">
                <a:solidFill>
                  <a:srgbClr val="000000"/>
                </a:solidFill>
                <a:latin typeface="Calibri"/>
              </a:rPr>
              <a:t>8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 to 1.56 x 10</a:t>
            </a:r>
            <a:r>
              <a:rPr b="0" lang="en-GB" sz="1800" spc="-1" strike="noStrike" baseline="30000">
                <a:solidFill>
                  <a:srgbClr val="000000"/>
                </a:solidFill>
                <a:latin typeface="Calibri"/>
              </a:rPr>
              <a:t>6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.  Each was probed with polyclonal anti-Protein G antibodies (diluted 1:2000) followed by goat anti-rabbit HRP (diluted 1:2500) and visualised with ECL detection reagent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03T12:46:30Z</dcterms:created>
  <dc:creator>MStevenson</dc:creator>
  <dc:description/>
  <dc:language>en-US</dc:language>
  <cp:lastModifiedBy>MStevenson</cp:lastModifiedBy>
  <dcterms:modified xsi:type="dcterms:W3CDTF">2010-10-04T15:30:29Z</dcterms:modified>
  <cp:revision>8</cp:revision>
  <dc:subject/>
  <dc:title>Slide 1</dc:title>
</cp:coreProperties>
</file>